
<file path=[Content_Types].xml><?xml version="1.0" encoding="utf-8"?>
<Types xmlns="http://schemas.openxmlformats.org/package/2006/content-types"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autoCompressPictures="0" strictFirstAndLastChars="0" saveSubsetFonts="1">
  <p:sldMasterIdLst>
    <p:sldMasterId id="2147483659" r:id="rId5"/>
  </p:sldMasterIdLst>
  <p:notesMasterIdLst>
    <p:notesMasterId r:id="rId6"/>
  </p:notesMasterIdLst>
  <p:sldIdLst>
    <p:sldId id="256" r:id="rId7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/>
</file>

<file path=ppt/tableStyles.xml><?xml version="1.0" encoding="utf-8"?>
<a:tblStyleLst xmlns:a="http://schemas.openxmlformats.org/drawingml/2006/main" xmlns:r="http://schemas.openxmlformats.org/officeDocument/2006/relationships" def="{37811CE3-E848-475A-89A7-3CDBEC861696}">
  <a:tblStyle styleId="{37811CE3-E848-475A-89A7-3CDBEC861696}" styleName="Table_0">
    <a:wholeTbl>
      <a:tcTxStyle>
        <a:font>
          <a:latin typeface="Calibri"/>
          <a:ea typeface="Calibri"/>
          <a:cs typeface="Calibri"/>
        </a:font>
        <a:srgbClr val="000000"/>
      </a:tcTxStyle>
      <a:tcStyle>
        <a:tcBdr>
          <a:left>
            <a:ln cap="flat" cmpd="sng" w="6350">
              <a:solidFill>
                <a:srgbClr val="666666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6350">
              <a:solidFill>
                <a:srgbClr val="666666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6350">
              <a:solidFill>
                <a:srgbClr val="7F7F7F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6350">
              <a:solidFill>
                <a:srgbClr val="7F7F7F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6350">
              <a:solidFill>
                <a:srgbClr val="666666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6350">
              <a:solidFill>
                <a:srgbClr val="666666"/>
              </a:solidFill>
              <a:prstDash val="solid"/>
              <a:round/>
              <a:headEnd len="sm" w="sm" type="none"/>
              <a:tailEnd len="sm" w="sm" type="none"/>
            </a:ln>
          </a:insideV>
        </a:tcBdr>
      </a:tc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/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43dca46a51_0_1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43dca46a51_0_1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/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/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/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/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/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/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/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Google Shape;54;p13"/>
          <p:cNvGraphicFramePr/>
          <p:nvPr/>
        </p:nvGraphicFramePr>
        <p:xfrm>
          <a:off x="530200" y="1002490"/>
          <a:ext cx="3000000" cy="3000000"/>
        </p:xfrm>
        <a:graphic>
          <a:graphicData uri="http://schemas.openxmlformats.org/drawingml/2006/table">
            <a:tbl>
              <a:tblPr bandRow="1">
                <a:noFill/>
                <a:tableStyleId>{37811CE3-E848-475A-89A7-3CDBEC861696}</a:tableStyleId>
              </a:tblPr>
              <a:tblGrid>
                <a:gridCol w="3006100"/>
                <a:gridCol w="3006100"/>
              </a:tblGrid>
              <a:tr h="1270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lberta Prion Research Institute 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Nova Scotia Health Research Foundation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lzheimer Research UK 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Ontario Brain Institute 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lzheimer Society of Canada 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fizer Inc.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anadian Nurses Foundation 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Robin and Barry Picov Family Foundation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Fonds de recherche du Québec – Santé 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anofi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ichael Smith Foundation for Health Research 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askatchewan Health Research Foundation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New Brunswick Health Research Foundation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</a:tcPr>
                </a:tc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Women’s Brain Health Initiative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</a:tcPr>
                </a:tc>
              </a:tr>
            </a:tbl>
          </a:graphicData>
        </a:graphic>
      </p:graphicFrame>
      <p:sp>
        <p:nvSpPr>
          <p:cNvPr id="55" name="Google Shape;55;p13"/>
          <p:cNvSpPr txBox="1"/>
          <p:nvPr/>
        </p:nvSpPr>
        <p:spPr>
          <a:xfrm>
            <a:off x="1131300" y="427175"/>
            <a:ext cx="3059100" cy="471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ppendix 1: CCNA partners</a:t>
            </a:r>
            <a:endParaRPr b="1" sz="12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